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3265" autoAdjust="0"/>
    <p:restoredTop sz="92674" autoAdjust="0"/>
  </p:normalViewPr>
  <p:slideViewPr>
    <p:cSldViewPr snapToGrid="0" showGuides="1">
      <p:cViewPr>
        <p:scale>
          <a:sx n="250" d="100"/>
          <a:sy n="250" d="100"/>
        </p:scale>
        <p:origin x="-210" y="9774"/>
      </p:cViewPr>
      <p:guideLst>
        <p:guide orient="horz" pos="4089"/>
        <p:guide orient="horz" pos="5152"/>
        <p:guide orient="horz" pos="2503"/>
        <p:guide orient="horz" pos="695"/>
        <p:guide pos="1225"/>
        <p:guide pos="3077"/>
        <p:guide pos="1389"/>
        <p:guide pos="746"/>
        <p:guide pos="492"/>
        <p:guide pos="21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Statistische%20Analysen\1308090%20TTest%20f&#252;r%20alle%20Versuche%20nur%20mit%20+-TNF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IF%20V14\130910%20Auswertung%201h%204h%2012h%20nach%20IR%20IF%20V%2013%2014%203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IF%20V14\130910%20Auswertung%201h%204h%2012h%20nach%20IR%20IF%20V%2013%2014%203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IF%20V14\130910%20Auswertung%201h%204h%2012h%20nach%20IR%20IF%20V%2013%2014%203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IF%20V14\130910%20Auswertung%201h%204h%2012h%20nach%20IR%20IF%20V%2013%2014%2033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Martin\Auswertung%20Foci\Statistische%20Analysen\1308090%20TTest%20f&#252;r%20alle%20Versuche%20nur%20mit%20+-TNF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300" b="0" dirty="0" smtClean="0"/>
              <a:t>S/G2 24 h</a:t>
            </a:r>
            <a:endParaRPr lang="en-US" sz="1300" b="0" dirty="0"/>
          </a:p>
        </c:rich>
      </c:tx>
      <c:layout>
        <c:manualLayout>
          <c:xMode val="edge"/>
          <c:yMode val="edge"/>
          <c:x val="0.42885629629629601"/>
          <c:y val="0.1060378612219050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656703703703699"/>
          <c:y val="0.26045549662630502"/>
          <c:w val="0.74169222222222198"/>
          <c:h val="0.518815980128337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'!$Q$13:$U$13</c:f>
                <c:numCache>
                  <c:formatCode>General</c:formatCode>
                  <c:ptCount val="5"/>
                  <c:pt idx="0">
                    <c:v>1.0707140474601811</c:v>
                  </c:pt>
                  <c:pt idx="1">
                    <c:v>1.360026697917224</c:v>
                  </c:pt>
                  <c:pt idx="2">
                    <c:v>0.863426865681716</c:v>
                  </c:pt>
                  <c:pt idx="3">
                    <c:v>0.99783098101164902</c:v>
                  </c:pt>
                  <c:pt idx="4">
                    <c:v>0.99652670621036799</c:v>
                  </c:pt>
                </c:numCache>
              </c:numRef>
            </c:plus>
            <c:minus>
              <c:numRef>
                <c:f>'G1 G2 nur+-TNF'!$Q$13:$U$13</c:f>
                <c:numCache>
                  <c:formatCode>General</c:formatCode>
                  <c:ptCount val="5"/>
                  <c:pt idx="0">
                    <c:v>1.0707140474601811</c:v>
                  </c:pt>
                  <c:pt idx="1">
                    <c:v>1.360026697917224</c:v>
                  </c:pt>
                  <c:pt idx="2">
                    <c:v>0.863426865681716</c:v>
                  </c:pt>
                  <c:pt idx="3">
                    <c:v>0.99783098101164902</c:v>
                  </c:pt>
                  <c:pt idx="4">
                    <c:v>0.99652670621036799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'!$J$13:$N$13</c:f>
              <c:numCache>
                <c:formatCode>0.00</c:formatCode>
                <c:ptCount val="5"/>
                <c:pt idx="0">
                  <c:v>4.9392857142857149</c:v>
                </c:pt>
                <c:pt idx="1">
                  <c:v>5.3035714285714279</c:v>
                </c:pt>
                <c:pt idx="2">
                  <c:v>6.0214285714285696</c:v>
                </c:pt>
                <c:pt idx="3">
                  <c:v>5.433333333333338</c:v>
                </c:pt>
                <c:pt idx="4">
                  <c:v>5.7071428571428546</c:v>
                </c:pt>
              </c:numCache>
            </c:numRef>
          </c:val>
        </c:ser>
        <c:ser>
          <c:idx val="1"/>
          <c:order val="1"/>
          <c:tx>
            <c:strRef>
              <c:f>'G1 G2 nur+-TNF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'!$Q$14:$U$14</c:f>
                <c:numCache>
                  <c:formatCode>General</c:formatCode>
                  <c:ptCount val="5"/>
                  <c:pt idx="0">
                    <c:v>1.3942377162893731</c:v>
                  </c:pt>
                  <c:pt idx="1">
                    <c:v>0.89287857117143299</c:v>
                  </c:pt>
                  <c:pt idx="2">
                    <c:v>0.96430335080872998</c:v>
                  </c:pt>
                  <c:pt idx="3">
                    <c:v>0.43001937940826201</c:v>
                  </c:pt>
                  <c:pt idx="4">
                    <c:v>0.83036136711675301</c:v>
                  </c:pt>
                </c:numCache>
              </c:numRef>
            </c:plus>
            <c:minus>
              <c:numRef>
                <c:f>'G1 G2 nur+-TNF'!$Q$14:$U$14</c:f>
                <c:numCache>
                  <c:formatCode>General</c:formatCode>
                  <c:ptCount val="5"/>
                  <c:pt idx="0">
                    <c:v>1.3942377162893731</c:v>
                  </c:pt>
                  <c:pt idx="1">
                    <c:v>0.89287857117143299</c:v>
                  </c:pt>
                  <c:pt idx="2">
                    <c:v>0.96430335080872998</c:v>
                  </c:pt>
                  <c:pt idx="3">
                    <c:v>0.43001937940826201</c:v>
                  </c:pt>
                  <c:pt idx="4">
                    <c:v>0.83036136711675301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'!$J$14:$N$14</c:f>
              <c:numCache>
                <c:formatCode>0.00</c:formatCode>
                <c:ptCount val="5"/>
                <c:pt idx="0">
                  <c:v>5.3178571428571404</c:v>
                </c:pt>
                <c:pt idx="1">
                  <c:v>4.9821428571428568</c:v>
                </c:pt>
                <c:pt idx="2">
                  <c:v>6.6214285714285692</c:v>
                </c:pt>
                <c:pt idx="3">
                  <c:v>5.6083333333333316</c:v>
                </c:pt>
                <c:pt idx="4">
                  <c:v>5.9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310848"/>
        <c:axId val="81312768"/>
      </c:barChart>
      <c:catAx>
        <c:axId val="813108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sz="1300" dirty="0"/>
                  <a:t>Dose [Gy]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1312768"/>
        <c:crosses val="autoZero"/>
        <c:auto val="1"/>
        <c:lblAlgn val="ctr"/>
        <c:lblOffset val="100"/>
        <c:noMultiLvlLbl val="0"/>
      </c:catAx>
      <c:valAx>
        <c:axId val="8131276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131084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400" b="0" dirty="0" smtClean="0"/>
              <a:t>G1 4 h</a:t>
            </a:r>
            <a:endParaRPr lang="en-US" sz="1400" b="0" dirty="0"/>
          </a:p>
        </c:rich>
      </c:tx>
      <c:layout>
        <c:manualLayout>
          <c:xMode val="edge"/>
          <c:yMode val="edge"/>
          <c:x val="0.46937888888888901"/>
          <c:y val="0.1274078870161670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23312222222222"/>
          <c:y val="0.24720076397356699"/>
          <c:w val="0.724947037037037"/>
          <c:h val="0.632828946109596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 4h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 4h'!$Q$8:$U$8</c:f>
                <c:numCache>
                  <c:formatCode>General</c:formatCode>
                  <c:ptCount val="5"/>
                  <c:pt idx="0">
                    <c:v>0.49138409959351897</c:v>
                  </c:pt>
                  <c:pt idx="1">
                    <c:v>0.70533679898329305</c:v>
                  </c:pt>
                  <c:pt idx="2">
                    <c:v>0.90007024944349101</c:v>
                  </c:pt>
                  <c:pt idx="3">
                    <c:v>1.3556210139022351</c:v>
                  </c:pt>
                  <c:pt idx="4">
                    <c:v>1.677858257819572</c:v>
                  </c:pt>
                </c:numCache>
              </c:numRef>
            </c:plus>
            <c:minus>
              <c:numRef>
                <c:f>'G1 G2 nur+-TNF 4h'!$Q$8:$U$8</c:f>
                <c:numCache>
                  <c:formatCode>General</c:formatCode>
                  <c:ptCount val="5"/>
                  <c:pt idx="0">
                    <c:v>0.49138409959351897</c:v>
                  </c:pt>
                  <c:pt idx="1">
                    <c:v>0.70533679898329305</c:v>
                  </c:pt>
                  <c:pt idx="2">
                    <c:v>0.90007024944349101</c:v>
                  </c:pt>
                  <c:pt idx="3">
                    <c:v>1.3556210139022351</c:v>
                  </c:pt>
                  <c:pt idx="4">
                    <c:v>1.677858257819572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 4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4h'!$J$8:$N$8</c:f>
              <c:numCache>
                <c:formatCode>0.00</c:formatCode>
                <c:ptCount val="5"/>
                <c:pt idx="0">
                  <c:v>1.3166666666666671</c:v>
                </c:pt>
                <c:pt idx="1">
                  <c:v>2.5750000000000002</c:v>
                </c:pt>
                <c:pt idx="2">
                  <c:v>3.7391414141414141</c:v>
                </c:pt>
                <c:pt idx="3">
                  <c:v>5.8666666666666671</c:v>
                </c:pt>
                <c:pt idx="4">
                  <c:v>6.6083333333333334</c:v>
                </c:pt>
              </c:numCache>
            </c:numRef>
          </c:val>
        </c:ser>
        <c:ser>
          <c:idx val="1"/>
          <c:order val="1"/>
          <c:tx>
            <c:strRef>
              <c:f>'G1 G2 nur+-TNF 4h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 4h'!$Q$9:$U$9</c:f>
                <c:numCache>
                  <c:formatCode>General</c:formatCode>
                  <c:ptCount val="5"/>
                  <c:pt idx="0">
                    <c:v>0.62366524140225399</c:v>
                  </c:pt>
                  <c:pt idx="1">
                    <c:v>0.215541952606293</c:v>
                  </c:pt>
                  <c:pt idx="2">
                    <c:v>1.0625245095212319</c:v>
                  </c:pt>
                  <c:pt idx="3">
                    <c:v>1.86033151167563</c:v>
                  </c:pt>
                  <c:pt idx="4">
                    <c:v>2.1384866144074861</c:v>
                  </c:pt>
                </c:numCache>
              </c:numRef>
            </c:plus>
            <c:minus>
              <c:numRef>
                <c:f>'G1 G2 nur+-TNF 4h'!$Q$9:$U$9</c:f>
                <c:numCache>
                  <c:formatCode>General</c:formatCode>
                  <c:ptCount val="5"/>
                  <c:pt idx="0">
                    <c:v>0.62366524140225399</c:v>
                  </c:pt>
                  <c:pt idx="1">
                    <c:v>0.215541952606293</c:v>
                  </c:pt>
                  <c:pt idx="2">
                    <c:v>1.0625245095212319</c:v>
                  </c:pt>
                  <c:pt idx="3">
                    <c:v>1.86033151167563</c:v>
                  </c:pt>
                  <c:pt idx="4">
                    <c:v>2.1384866144074861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 4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4h'!$J$9:$N$9</c:f>
              <c:numCache>
                <c:formatCode>0.00</c:formatCode>
                <c:ptCount val="5"/>
                <c:pt idx="0">
                  <c:v>1.3916666666666671</c:v>
                </c:pt>
                <c:pt idx="1">
                  <c:v>2.5083333333333342</c:v>
                </c:pt>
                <c:pt idx="2">
                  <c:v>4.0583333333333362</c:v>
                </c:pt>
                <c:pt idx="3">
                  <c:v>5.916666666666667</c:v>
                </c:pt>
                <c:pt idx="4">
                  <c:v>7.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351040"/>
        <c:axId val="81352576"/>
      </c:barChart>
      <c:catAx>
        <c:axId val="81351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1352576"/>
        <c:crosses val="autoZero"/>
        <c:auto val="1"/>
        <c:lblAlgn val="ctr"/>
        <c:lblOffset val="100"/>
        <c:noMultiLvlLbl val="0"/>
      </c:catAx>
      <c:valAx>
        <c:axId val="813525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300"/>
                </a:pPr>
                <a:r>
                  <a:rPr lang="en-US" sz="1300">
                    <a:latin typeface="Symbol" panose="05050102010706020507" pitchFamily="18" charset="2"/>
                  </a:rPr>
                  <a:t>g</a:t>
                </a:r>
                <a:r>
                  <a:rPr lang="en-US" sz="1300"/>
                  <a:t>H2AX</a:t>
                </a:r>
                <a:r>
                  <a:rPr lang="en-US" sz="1300" baseline="0"/>
                  <a:t> foci/cell</a:t>
                </a:r>
                <a:endParaRPr lang="en-US" sz="1300"/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13510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400" b="0" dirty="0" smtClean="0"/>
              <a:t>S/G2</a:t>
            </a:r>
            <a:r>
              <a:rPr lang="en-US" sz="1400" b="0" baseline="0" dirty="0" smtClean="0"/>
              <a:t> 4h</a:t>
            </a:r>
            <a:endParaRPr lang="en-US" sz="1400" b="0" dirty="0"/>
          </a:p>
        </c:rich>
      </c:tx>
      <c:layout>
        <c:manualLayout>
          <c:xMode val="edge"/>
          <c:yMode val="edge"/>
          <c:x val="0.44115666666666697"/>
          <c:y val="0.11263499411955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449740740740699"/>
          <c:y val="0.24720076397356699"/>
          <c:w val="0.74376185185185195"/>
          <c:h val="0.632828946109596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 4h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 4h'!$Q$13:$U$13</c:f>
                <c:numCache>
                  <c:formatCode>General</c:formatCode>
                  <c:ptCount val="5"/>
                  <c:pt idx="0">
                    <c:v>0.65383484153109706</c:v>
                  </c:pt>
                  <c:pt idx="1">
                    <c:v>1.3730288902034571</c:v>
                  </c:pt>
                  <c:pt idx="2">
                    <c:v>1.5788826335007831</c:v>
                  </c:pt>
                  <c:pt idx="3">
                    <c:v>3.432321857479772</c:v>
                  </c:pt>
                  <c:pt idx="4">
                    <c:v>2.3527023469477268</c:v>
                  </c:pt>
                </c:numCache>
              </c:numRef>
            </c:plus>
            <c:minus>
              <c:numRef>
                <c:f>'G1 G2 nur+-TNF 4h'!$Q$13:$U$13</c:f>
                <c:numCache>
                  <c:formatCode>General</c:formatCode>
                  <c:ptCount val="5"/>
                  <c:pt idx="0">
                    <c:v>0.65383484153109706</c:v>
                  </c:pt>
                  <c:pt idx="1">
                    <c:v>1.3730288902034571</c:v>
                  </c:pt>
                  <c:pt idx="2">
                    <c:v>1.5788826335007831</c:v>
                  </c:pt>
                  <c:pt idx="3">
                    <c:v>3.432321857479772</c:v>
                  </c:pt>
                  <c:pt idx="4">
                    <c:v>2.3527023469477268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 4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4h'!$J$13:$N$13</c:f>
              <c:numCache>
                <c:formatCode>0.00</c:formatCode>
                <c:ptCount val="5"/>
                <c:pt idx="0">
                  <c:v>5.2750000000000004</c:v>
                </c:pt>
                <c:pt idx="1">
                  <c:v>7.1416666666666666</c:v>
                </c:pt>
                <c:pt idx="2">
                  <c:v>8.7388888888888854</c:v>
                </c:pt>
                <c:pt idx="3">
                  <c:v>11.40833333333333</c:v>
                </c:pt>
                <c:pt idx="4">
                  <c:v>12.78333333333333</c:v>
                </c:pt>
              </c:numCache>
            </c:numRef>
          </c:val>
        </c:ser>
        <c:ser>
          <c:idx val="1"/>
          <c:order val="1"/>
          <c:tx>
            <c:strRef>
              <c:f>'G1 G2 nur+-TNF 4h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 4h'!$Q$14:$U$14</c:f>
                <c:numCache>
                  <c:formatCode>General</c:formatCode>
                  <c:ptCount val="5"/>
                  <c:pt idx="0">
                    <c:v>1.025406423489406</c:v>
                  </c:pt>
                  <c:pt idx="1">
                    <c:v>0.302420788527068</c:v>
                  </c:pt>
                  <c:pt idx="2">
                    <c:v>1.6590660023037049</c:v>
                  </c:pt>
                  <c:pt idx="3">
                    <c:v>2.4861281811952778</c:v>
                  </c:pt>
                  <c:pt idx="4">
                    <c:v>2.9394231293458488</c:v>
                  </c:pt>
                </c:numCache>
              </c:numRef>
            </c:plus>
            <c:minus>
              <c:numRef>
                <c:f>'G1 G2 nur+-TNF 4h'!$Q$14:$U$14</c:f>
                <c:numCache>
                  <c:formatCode>General</c:formatCode>
                  <c:ptCount val="5"/>
                  <c:pt idx="0">
                    <c:v>1.025406423489406</c:v>
                  </c:pt>
                  <c:pt idx="1">
                    <c:v>0.302420788527068</c:v>
                  </c:pt>
                  <c:pt idx="2">
                    <c:v>1.6590660023037049</c:v>
                  </c:pt>
                  <c:pt idx="3">
                    <c:v>2.4861281811952778</c:v>
                  </c:pt>
                  <c:pt idx="4">
                    <c:v>2.9394231293458488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 4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4h'!$J$14:$N$14</c:f>
              <c:numCache>
                <c:formatCode>0.00</c:formatCode>
                <c:ptCount val="5"/>
                <c:pt idx="0">
                  <c:v>5.1583333333333332</c:v>
                </c:pt>
                <c:pt idx="1">
                  <c:v>6.5666666666666664</c:v>
                </c:pt>
                <c:pt idx="2">
                  <c:v>8.5250000000000004</c:v>
                </c:pt>
                <c:pt idx="3">
                  <c:v>11.19166666666667</c:v>
                </c:pt>
                <c:pt idx="4">
                  <c:v>12.808333333333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1390976"/>
        <c:axId val="81392768"/>
      </c:barChart>
      <c:catAx>
        <c:axId val="813909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1392768"/>
        <c:crosses val="autoZero"/>
        <c:auto val="1"/>
        <c:lblAlgn val="ctr"/>
        <c:lblOffset val="100"/>
        <c:noMultiLvlLbl val="0"/>
      </c:catAx>
      <c:valAx>
        <c:axId val="81392768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139097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400" b="0" dirty="0" smtClean="0"/>
              <a:t>G1 1 h</a:t>
            </a:r>
            <a:endParaRPr lang="en-US" sz="1400" b="0" dirty="0"/>
          </a:p>
        </c:rich>
      </c:tx>
      <c:layout>
        <c:manualLayout>
          <c:xMode val="edge"/>
          <c:yMode val="edge"/>
          <c:x val="0.474082592592593"/>
          <c:y val="0.1502206759663330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23312222222222"/>
          <c:y val="0.29081379771376098"/>
          <c:w val="0.724947037037037"/>
          <c:h val="0.5776055579742299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 1h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 1h'!$Q$8:$U$8</c:f>
                <c:numCache>
                  <c:formatCode>General</c:formatCode>
                  <c:ptCount val="5"/>
                  <c:pt idx="0">
                    <c:v>0.17320508075688801</c:v>
                  </c:pt>
                  <c:pt idx="1">
                    <c:v>0.336340601176843</c:v>
                  </c:pt>
                  <c:pt idx="2">
                    <c:v>1.23043014159006</c:v>
                  </c:pt>
                  <c:pt idx="3">
                    <c:v>1.8569127604709921</c:v>
                  </c:pt>
                  <c:pt idx="4">
                    <c:v>1.4571661996262939</c:v>
                  </c:pt>
                </c:numCache>
              </c:numRef>
            </c:plus>
            <c:minus>
              <c:numRef>
                <c:f>'G1 G2 nur+-TNF 1h'!$Q$8:$U$8</c:f>
                <c:numCache>
                  <c:formatCode>General</c:formatCode>
                  <c:ptCount val="5"/>
                  <c:pt idx="0">
                    <c:v>0.17320508075688801</c:v>
                  </c:pt>
                  <c:pt idx="1">
                    <c:v>0.336340601176843</c:v>
                  </c:pt>
                  <c:pt idx="2">
                    <c:v>1.23043014159006</c:v>
                  </c:pt>
                  <c:pt idx="3">
                    <c:v>1.8569127604709921</c:v>
                  </c:pt>
                  <c:pt idx="4">
                    <c:v>1.4571661996262939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 1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1h'!$J$8:$N$8</c:f>
              <c:numCache>
                <c:formatCode>0.00</c:formatCode>
                <c:ptCount val="5"/>
                <c:pt idx="0">
                  <c:v>1.075</c:v>
                </c:pt>
                <c:pt idx="1">
                  <c:v>7.3999999999999986</c:v>
                </c:pt>
                <c:pt idx="2">
                  <c:v>12.41666666666667</c:v>
                </c:pt>
                <c:pt idx="3">
                  <c:v>16.5</c:v>
                </c:pt>
                <c:pt idx="4">
                  <c:v>19.858333333333299</c:v>
                </c:pt>
              </c:numCache>
            </c:numRef>
          </c:val>
        </c:ser>
        <c:ser>
          <c:idx val="1"/>
          <c:order val="1"/>
          <c:tx>
            <c:strRef>
              <c:f>'G1 G2 nur+-TNF 1h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 1h'!$Q$9:$U$9</c:f>
                <c:numCache>
                  <c:formatCode>General</c:formatCode>
                  <c:ptCount val="5"/>
                  <c:pt idx="0">
                    <c:v>0.125</c:v>
                  </c:pt>
                  <c:pt idx="1">
                    <c:v>0.74847066297439702</c:v>
                  </c:pt>
                  <c:pt idx="2">
                    <c:v>0.34125992049072201</c:v>
                  </c:pt>
                  <c:pt idx="3">
                    <c:v>0.98276819918703695</c:v>
                  </c:pt>
                  <c:pt idx="4">
                    <c:v>2.757829762693853</c:v>
                  </c:pt>
                </c:numCache>
              </c:numRef>
            </c:plus>
            <c:minus>
              <c:numRef>
                <c:f>'G1 G2 nur+-TNF 1h'!$Q$9:$U$9</c:f>
                <c:numCache>
                  <c:formatCode>General</c:formatCode>
                  <c:ptCount val="5"/>
                  <c:pt idx="0">
                    <c:v>0.125</c:v>
                  </c:pt>
                  <c:pt idx="1">
                    <c:v>0.74847066297439702</c:v>
                  </c:pt>
                  <c:pt idx="2">
                    <c:v>0.34125992049072201</c:v>
                  </c:pt>
                  <c:pt idx="3">
                    <c:v>0.98276819918703695</c:v>
                  </c:pt>
                  <c:pt idx="4">
                    <c:v>2.757829762693853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 1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1h'!$J$9:$N$9</c:f>
              <c:numCache>
                <c:formatCode>0.00</c:formatCode>
                <c:ptCount val="5"/>
                <c:pt idx="0">
                  <c:v>1.2749999999999999</c:v>
                </c:pt>
                <c:pt idx="1">
                  <c:v>7.8416666666666659</c:v>
                </c:pt>
                <c:pt idx="2">
                  <c:v>13.258333333333329</c:v>
                </c:pt>
                <c:pt idx="3">
                  <c:v>16.166666666666671</c:v>
                </c:pt>
                <c:pt idx="4">
                  <c:v>19.6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694720"/>
        <c:axId val="85704704"/>
      </c:barChart>
      <c:catAx>
        <c:axId val="85694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5704704"/>
        <c:crosses val="autoZero"/>
        <c:auto val="1"/>
        <c:lblAlgn val="ctr"/>
        <c:lblOffset val="100"/>
        <c:noMultiLvlLbl val="0"/>
      </c:catAx>
      <c:valAx>
        <c:axId val="85704704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300"/>
                </a:pPr>
                <a:r>
                  <a:rPr lang="en-US" sz="1300">
                    <a:latin typeface="Symbol" panose="05050102010706020507" pitchFamily="18" charset="2"/>
                  </a:rPr>
                  <a:t>g</a:t>
                </a:r>
                <a:r>
                  <a:rPr lang="en-US" sz="1300"/>
                  <a:t>H2AX</a:t>
                </a:r>
                <a:r>
                  <a:rPr lang="en-US" sz="1300" baseline="0"/>
                  <a:t> foci/cell</a:t>
                </a:r>
                <a:endParaRPr lang="en-US" sz="1300"/>
              </a:p>
            </c:rich>
          </c:tx>
          <c:layout>
            <c:manualLayout>
              <c:xMode val="edge"/>
              <c:yMode val="edge"/>
              <c:x val="0"/>
              <c:y val="0.30770437089893199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5694720"/>
        <c:crosses val="autoZero"/>
        <c:crossBetween val="between"/>
      </c:valAx>
    </c:plotArea>
    <c:legend>
      <c:legendPos val="t"/>
      <c:layout>
        <c:manualLayout>
          <c:xMode val="edge"/>
          <c:yMode val="edge"/>
          <c:x val="0.27814037037036998"/>
          <c:y val="0.27112409097794499"/>
          <c:w val="0.51897814814814802"/>
          <c:h val="8.26854740765358E-2"/>
        </c:manualLayout>
      </c:layout>
      <c:overlay val="0"/>
      <c:txPr>
        <a:bodyPr/>
        <a:lstStyle/>
        <a:p>
          <a:pPr>
            <a:defRPr sz="1000" b="0"/>
          </a:pPr>
          <a:endParaRPr lang="de-DE"/>
        </a:p>
      </c:txPr>
    </c:legend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400" b="0" dirty="0" smtClean="0"/>
              <a:t>S/G2 1 h</a:t>
            </a:r>
            <a:endParaRPr lang="en-US" sz="1400" b="0" dirty="0"/>
          </a:p>
        </c:rich>
      </c:tx>
      <c:layout>
        <c:manualLayout>
          <c:xMode val="edge"/>
          <c:yMode val="edge"/>
          <c:x val="0.41293444444444399"/>
          <c:y val="0.15022067596633301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0449740740740699"/>
          <c:y val="0.290507404005859"/>
          <c:w val="0.74376185185185195"/>
          <c:h val="0.5779119516821320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 1h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 1h'!$Q$13:$U$13</c:f>
                <c:numCache>
                  <c:formatCode>General</c:formatCode>
                  <c:ptCount val="5"/>
                  <c:pt idx="0">
                    <c:v>0.33572061797472802</c:v>
                  </c:pt>
                  <c:pt idx="1">
                    <c:v>0.55283360968739903</c:v>
                  </c:pt>
                  <c:pt idx="2">
                    <c:v>0.118145390656316</c:v>
                  </c:pt>
                  <c:pt idx="3">
                    <c:v>3.451479151513634</c:v>
                  </c:pt>
                  <c:pt idx="4">
                    <c:v>2.6940907557096141</c:v>
                  </c:pt>
                </c:numCache>
              </c:numRef>
            </c:plus>
            <c:minus>
              <c:numRef>
                <c:f>'G1 G2 nur+-TNF 1h'!$Q$13:$U$13</c:f>
                <c:numCache>
                  <c:formatCode>General</c:formatCode>
                  <c:ptCount val="5"/>
                  <c:pt idx="0">
                    <c:v>0.33572061797472802</c:v>
                  </c:pt>
                  <c:pt idx="1">
                    <c:v>0.55283360968739903</c:v>
                  </c:pt>
                  <c:pt idx="2">
                    <c:v>0.118145390656316</c:v>
                  </c:pt>
                  <c:pt idx="3">
                    <c:v>3.451479151513634</c:v>
                  </c:pt>
                  <c:pt idx="4">
                    <c:v>2.6940907557096141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 1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1h'!$J$13:$N$13</c:f>
              <c:numCache>
                <c:formatCode>0.00</c:formatCode>
                <c:ptCount val="5"/>
                <c:pt idx="0">
                  <c:v>4.8166666666666664</c:v>
                </c:pt>
                <c:pt idx="1">
                  <c:v>13.45</c:v>
                </c:pt>
                <c:pt idx="2">
                  <c:v>21.36666666666666</c:v>
                </c:pt>
                <c:pt idx="3">
                  <c:v>26.558333333333302</c:v>
                </c:pt>
                <c:pt idx="4">
                  <c:v>34.1</c:v>
                </c:pt>
              </c:numCache>
            </c:numRef>
          </c:val>
        </c:ser>
        <c:ser>
          <c:idx val="1"/>
          <c:order val="1"/>
          <c:tx>
            <c:strRef>
              <c:f>'G1 G2 nur+-TNF 1h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 1h'!$Q$14:$U$14</c:f>
                <c:numCache>
                  <c:formatCode>General</c:formatCode>
                  <c:ptCount val="5"/>
                  <c:pt idx="0">
                    <c:v>0.35</c:v>
                  </c:pt>
                  <c:pt idx="1">
                    <c:v>1.400074402784842</c:v>
                  </c:pt>
                  <c:pt idx="2">
                    <c:v>1.960920277148801</c:v>
                  </c:pt>
                  <c:pt idx="3">
                    <c:v>3.078671667496891</c:v>
                  </c:pt>
                  <c:pt idx="4">
                    <c:v>1.826939608562181</c:v>
                  </c:pt>
                </c:numCache>
              </c:numRef>
            </c:plus>
            <c:minus>
              <c:numRef>
                <c:f>'G1 G2 nur+-TNF 1h'!$Q$14:$U$14</c:f>
                <c:numCache>
                  <c:formatCode>General</c:formatCode>
                  <c:ptCount val="5"/>
                  <c:pt idx="0">
                    <c:v>0.35</c:v>
                  </c:pt>
                  <c:pt idx="1">
                    <c:v>1.400074402784842</c:v>
                  </c:pt>
                  <c:pt idx="2">
                    <c:v>1.960920277148801</c:v>
                  </c:pt>
                  <c:pt idx="3">
                    <c:v>3.078671667496891</c:v>
                  </c:pt>
                  <c:pt idx="4">
                    <c:v>1.826939608562181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 1h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 1h'!$J$14:$N$14</c:f>
              <c:numCache>
                <c:formatCode>0.00</c:formatCode>
                <c:ptCount val="5"/>
                <c:pt idx="0">
                  <c:v>5.4249999999999972</c:v>
                </c:pt>
                <c:pt idx="1">
                  <c:v>13.93333333333333</c:v>
                </c:pt>
                <c:pt idx="2">
                  <c:v>21.858333333333299</c:v>
                </c:pt>
                <c:pt idx="3">
                  <c:v>25.76004273504272</c:v>
                </c:pt>
                <c:pt idx="4">
                  <c:v>32.33333333333334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211008"/>
        <c:axId val="85212544"/>
      </c:barChart>
      <c:catAx>
        <c:axId val="85211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5212544"/>
        <c:crosses val="autoZero"/>
        <c:auto val="1"/>
        <c:lblAlgn val="ctr"/>
        <c:lblOffset val="100"/>
        <c:noMultiLvlLbl val="0"/>
      </c:catAx>
      <c:valAx>
        <c:axId val="8521254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521100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300"/>
            </a:pPr>
            <a:r>
              <a:rPr lang="en-US" sz="1300" b="0" dirty="0" smtClean="0"/>
              <a:t>G1 24 h </a:t>
            </a:r>
            <a:endParaRPr lang="en-US" sz="1300" b="0" dirty="0"/>
          </a:p>
        </c:rich>
      </c:tx>
      <c:layout>
        <c:manualLayout>
          <c:xMode val="edge"/>
          <c:yMode val="edge"/>
          <c:x val="0.41004148148148201"/>
          <c:y val="0.110456105439485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9715962962962999"/>
          <c:y val="0.26045549662630502"/>
          <c:w val="0.75109962962962995"/>
          <c:h val="0.5188159801283379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G1 G2 nur+-TNF'!$I$18</c:f>
              <c:strCache>
                <c:ptCount val="1"/>
                <c:pt idx="0">
                  <c:v> -TNF-α</c:v>
                </c:pt>
              </c:strCache>
            </c:strRef>
          </c:tx>
          <c:spPr>
            <a:noFill/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1 G2 nur+-TNF'!$Q$8:$U$8</c:f>
                <c:numCache>
                  <c:formatCode>General</c:formatCode>
                  <c:ptCount val="5"/>
                  <c:pt idx="0">
                    <c:v>0.36010084566357098</c:v>
                  </c:pt>
                  <c:pt idx="1">
                    <c:v>0.32564039470966399</c:v>
                  </c:pt>
                  <c:pt idx="2">
                    <c:v>0.251838478091851</c:v>
                  </c:pt>
                  <c:pt idx="3">
                    <c:v>0.19153981309378099</c:v>
                  </c:pt>
                  <c:pt idx="4">
                    <c:v>0.22769549423569299</c:v>
                  </c:pt>
                </c:numCache>
              </c:numRef>
            </c:plus>
            <c:minus>
              <c:numRef>
                <c:f>'G1 G2 nur+-TNF'!$Q$8:$U$8</c:f>
                <c:numCache>
                  <c:formatCode>General</c:formatCode>
                  <c:ptCount val="5"/>
                  <c:pt idx="0">
                    <c:v>0.36010084566357098</c:v>
                  </c:pt>
                  <c:pt idx="1">
                    <c:v>0.32564039470966399</c:v>
                  </c:pt>
                  <c:pt idx="2">
                    <c:v>0.251838478091851</c:v>
                  </c:pt>
                  <c:pt idx="3">
                    <c:v>0.19153981309378099</c:v>
                  </c:pt>
                  <c:pt idx="4">
                    <c:v>0.22769549423569299</c:v>
                  </c:pt>
                </c:numCache>
              </c:numRef>
            </c:minus>
            <c:spPr>
              <a:ln w="25400" cap="sq"/>
            </c:spPr>
          </c:errBars>
          <c:cat>
            <c:strRef>
              <c:f>'G1 G2 nur+-TNF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'!$J$8:$N$8</c:f>
              <c:numCache>
                <c:formatCode>0.00</c:formatCode>
                <c:ptCount val="5"/>
                <c:pt idx="0">
                  <c:v>1.1285714285714299</c:v>
                </c:pt>
                <c:pt idx="1">
                  <c:v>1.325</c:v>
                </c:pt>
                <c:pt idx="2">
                  <c:v>1.5535714285714299</c:v>
                </c:pt>
                <c:pt idx="3">
                  <c:v>1.5125</c:v>
                </c:pt>
                <c:pt idx="4">
                  <c:v>1.664285714285715</c:v>
                </c:pt>
              </c:numCache>
            </c:numRef>
          </c:val>
        </c:ser>
        <c:ser>
          <c:idx val="1"/>
          <c:order val="1"/>
          <c:tx>
            <c:strRef>
              <c:f>'G1 G2 nur+-TNF'!$I$19</c:f>
              <c:strCache>
                <c:ptCount val="1"/>
                <c:pt idx="0">
                  <c:v> +TNF-α</c:v>
                </c:pt>
              </c:strCache>
            </c:strRef>
          </c:tx>
          <c:spPr>
            <a:solidFill>
              <a:sysClr val="windowText" lastClr="000000"/>
            </a:solidFill>
            <a:ln w="2540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G1 G2 nur+-TNF'!$Q$9:$U$9</c:f>
                <c:numCache>
                  <c:formatCode>General</c:formatCode>
                  <c:ptCount val="5"/>
                  <c:pt idx="0">
                    <c:v>0.31880543402192002</c:v>
                  </c:pt>
                  <c:pt idx="1">
                    <c:v>0.27817432013209398</c:v>
                  </c:pt>
                  <c:pt idx="2">
                    <c:v>0.30889588321417799</c:v>
                  </c:pt>
                  <c:pt idx="3">
                    <c:v>0.33668110530094503</c:v>
                  </c:pt>
                  <c:pt idx="4">
                    <c:v>0.23278208693969499</c:v>
                  </c:pt>
                </c:numCache>
              </c:numRef>
            </c:plus>
            <c:minus>
              <c:numRef>
                <c:f>'G1 G2 nur+-TNF'!$Q$9:$U$9</c:f>
                <c:numCache>
                  <c:formatCode>General</c:formatCode>
                  <c:ptCount val="5"/>
                  <c:pt idx="0">
                    <c:v>0.31880543402192002</c:v>
                  </c:pt>
                  <c:pt idx="1">
                    <c:v>0.27817432013209398</c:v>
                  </c:pt>
                  <c:pt idx="2">
                    <c:v>0.30889588321417799</c:v>
                  </c:pt>
                  <c:pt idx="3">
                    <c:v>0.33668110530094503</c:v>
                  </c:pt>
                  <c:pt idx="4">
                    <c:v>0.23278208693969499</c:v>
                  </c:pt>
                </c:numCache>
              </c:numRef>
            </c:minus>
            <c:spPr>
              <a:ln w="25400" cap="sq">
                <a:solidFill>
                  <a:sysClr val="windowText" lastClr="000000">
                    <a:shade val="95000"/>
                    <a:satMod val="105000"/>
                  </a:sysClr>
                </a:solidFill>
              </a:ln>
            </c:spPr>
          </c:errBars>
          <c:cat>
            <c:strRef>
              <c:f>'G1 G2 nur+-TNF'!$J$17:$N$17</c:f>
              <c:strCache>
                <c:ptCount val="5"/>
                <c:pt idx="0">
                  <c:v>0</c:v>
                </c:pt>
                <c:pt idx="1">
                  <c:v>0.3</c:v>
                </c:pt>
                <c:pt idx="2">
                  <c:v>0.5</c:v>
                </c:pt>
                <c:pt idx="3">
                  <c:v>0.7</c:v>
                </c:pt>
                <c:pt idx="4">
                  <c:v>1</c:v>
                </c:pt>
              </c:strCache>
            </c:strRef>
          </c:cat>
          <c:val>
            <c:numRef>
              <c:f>'G1 G2 nur+-TNF'!$J$9:$N$9</c:f>
              <c:numCache>
                <c:formatCode>0.00</c:formatCode>
                <c:ptCount val="5"/>
                <c:pt idx="0">
                  <c:v>1.139285714285714</c:v>
                </c:pt>
                <c:pt idx="1">
                  <c:v>1.153571428571428</c:v>
                </c:pt>
                <c:pt idx="2">
                  <c:v>1.85</c:v>
                </c:pt>
                <c:pt idx="3">
                  <c:v>1.404166666666667</c:v>
                </c:pt>
                <c:pt idx="4">
                  <c:v>1.5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5250816"/>
        <c:axId val="85252736"/>
      </c:barChart>
      <c:catAx>
        <c:axId val="8525081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/>
                </a:pPr>
                <a:r>
                  <a:rPr lang="en-US" sz="1300" dirty="0"/>
                  <a:t>Dose [Gy]</a:t>
                </a:r>
              </a:p>
            </c:rich>
          </c:tx>
          <c:layout/>
          <c:overlay val="0"/>
        </c:title>
        <c:numFmt formatCode="General" sourceLinked="1"/>
        <c:majorTickMark val="none"/>
        <c:minorTickMark val="none"/>
        <c:tickLblPos val="nextTo"/>
        <c:spPr>
          <a:ln w="38100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200" b="1"/>
            </a:pPr>
            <a:endParaRPr lang="de-DE"/>
          </a:p>
        </c:txPr>
        <c:crossAx val="85252736"/>
        <c:crosses val="autoZero"/>
        <c:auto val="1"/>
        <c:lblAlgn val="ctr"/>
        <c:lblOffset val="100"/>
        <c:noMultiLvlLbl val="0"/>
      </c:catAx>
      <c:valAx>
        <c:axId val="8525273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300"/>
                </a:pPr>
                <a:r>
                  <a:rPr lang="en-US" sz="1300">
                    <a:latin typeface="Symbol" panose="05050102010706020507" pitchFamily="18" charset="2"/>
                  </a:rPr>
                  <a:t>g</a:t>
                </a:r>
                <a:r>
                  <a:rPr lang="en-US" sz="1300"/>
                  <a:t>H2AX</a:t>
                </a:r>
                <a:r>
                  <a:rPr lang="en-US" sz="1300" baseline="0"/>
                  <a:t> foci/cell</a:t>
                </a:r>
                <a:endParaRPr lang="en-US" sz="1300"/>
              </a:p>
            </c:rich>
          </c:tx>
          <c:layout>
            <c:manualLayout>
              <c:xMode val="edge"/>
              <c:yMode val="edge"/>
              <c:x val="1.29596296296296E-2"/>
              <c:y val="0.28308073384601201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38100" cap="sq">
            <a:solidFill>
              <a:sysClr val="windowText" lastClr="000000"/>
            </a:solidFill>
          </a:ln>
        </c:spPr>
        <c:txPr>
          <a:bodyPr rot="0" vert="horz"/>
          <a:lstStyle/>
          <a:p>
            <a:pPr>
              <a:defRPr sz="1100"/>
            </a:pPr>
            <a:endParaRPr lang="de-DE"/>
          </a:p>
        </c:txPr>
        <c:crossAx val="85250816"/>
        <c:crosses val="autoZero"/>
        <c:crossBetween val="between"/>
        <c:majorUnit val="1"/>
      </c:valAx>
    </c:plotArea>
    <c:plotVisOnly val="1"/>
    <c:dispBlanksAs val="gap"/>
    <c:showDLblsOverMax val="0"/>
  </c:chart>
  <c:txPr>
    <a:bodyPr/>
    <a:lstStyle/>
    <a:p>
      <a:pPr>
        <a:defRPr sz="1200" b="1" i="0" u="none" strike="noStrike" baseline="0">
          <a:solidFill>
            <a:srgbClr val="000000"/>
          </a:solidFill>
          <a:latin typeface="Arial" pitchFamily="34" charset="0"/>
          <a:ea typeface="Calibri"/>
          <a:cs typeface="Arial" pitchFamily="34" charset="0"/>
        </a:defRPr>
      </a:pPr>
      <a:endParaRPr lang="de-DE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A3703D-35EC-4E2C-8882-5877EA0E2691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33588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715153"/>
            <a:ext cx="548640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9428583"/>
            <a:ext cx="2971800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882D7E-90D6-4097-93E1-67DAAA7B06A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6124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D7E2C1-AF4F-452D-89A7-5083E506E26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7342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3705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345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8355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112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3209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284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882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082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36472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70712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908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DF4351-368C-4841-BB94-7545FB1CEB69}" type="datetimeFigureOut">
              <a:rPr lang="en-US" smtClean="0"/>
              <a:t>3/9/201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341A2-8787-4E0A-BE34-046604C3F824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61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ung 2"/>
          <p:cNvGrpSpPr/>
          <p:nvPr/>
        </p:nvGrpSpPr>
        <p:grpSpPr>
          <a:xfrm>
            <a:off x="678902" y="487477"/>
            <a:ext cx="5451364" cy="7738119"/>
            <a:chOff x="678902" y="487477"/>
            <a:chExt cx="5451364" cy="7738119"/>
          </a:xfrm>
        </p:grpSpPr>
        <p:graphicFrame>
          <p:nvGraphicFramePr>
            <p:cNvPr id="9" name="Diagramm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91026316"/>
                </p:ext>
              </p:extLst>
            </p:nvPr>
          </p:nvGraphicFramePr>
          <p:xfrm>
            <a:off x="3430266" y="5351151"/>
            <a:ext cx="2700000" cy="28744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4" name="Diagramm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99978076"/>
                </p:ext>
              </p:extLst>
            </p:nvPr>
          </p:nvGraphicFramePr>
          <p:xfrm>
            <a:off x="714360" y="3057945"/>
            <a:ext cx="2700000" cy="247115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5" name="Diagramm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95380872"/>
                </p:ext>
              </p:extLst>
            </p:nvPr>
          </p:nvGraphicFramePr>
          <p:xfrm>
            <a:off x="3417128" y="3051868"/>
            <a:ext cx="2700000" cy="24589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6" name="Diagramm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8004692"/>
                </p:ext>
              </p:extLst>
            </p:nvPr>
          </p:nvGraphicFramePr>
          <p:xfrm>
            <a:off x="711990" y="487477"/>
            <a:ext cx="2700000" cy="26208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7" name="Diagramm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1649807"/>
                </p:ext>
              </p:extLst>
            </p:nvPr>
          </p:nvGraphicFramePr>
          <p:xfrm>
            <a:off x="3423203" y="487477"/>
            <a:ext cx="2700000" cy="262081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8" name="Diagramm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661641357"/>
                </p:ext>
              </p:extLst>
            </p:nvPr>
          </p:nvGraphicFramePr>
          <p:xfrm>
            <a:off x="769047" y="5351151"/>
            <a:ext cx="2700000" cy="28744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10" name="Textfeld 9"/>
            <p:cNvSpPr txBox="1"/>
            <p:nvPr/>
          </p:nvSpPr>
          <p:spPr>
            <a:xfrm>
              <a:off x="678902" y="704875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3411990" y="704875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D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691054" y="3154862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B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3399838" y="3148785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E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03206" y="5547182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3418066" y="5547182"/>
              <a:ext cx="163392" cy="276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Arial" pitchFamily="34" charset="0"/>
                  <a:cs typeface="Arial" pitchFamily="34" charset="0"/>
                </a:rPr>
                <a:t>F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6" name="Gruppieren 15"/>
            <p:cNvGrpSpPr/>
            <p:nvPr/>
          </p:nvGrpSpPr>
          <p:grpSpPr>
            <a:xfrm>
              <a:off x="1912476" y="6211276"/>
              <a:ext cx="395390" cy="354418"/>
              <a:chOff x="1885456" y="3683839"/>
              <a:chExt cx="648000" cy="354418"/>
            </a:xfrm>
          </p:grpSpPr>
          <p:grpSp>
            <p:nvGrpSpPr>
              <p:cNvPr id="18" name="Gruppieren 17"/>
              <p:cNvGrpSpPr/>
              <p:nvPr/>
            </p:nvGrpSpPr>
            <p:grpSpPr>
              <a:xfrm>
                <a:off x="1885456" y="3880098"/>
                <a:ext cx="648000" cy="61676"/>
                <a:chOff x="1907704" y="3858693"/>
                <a:chExt cx="387739" cy="112684"/>
              </a:xfrm>
            </p:grpSpPr>
            <p:cxnSp>
              <p:nvCxnSpPr>
                <p:cNvPr id="20" name="Gerade Verbindung 19"/>
                <p:cNvCxnSpPr/>
                <p:nvPr/>
              </p:nvCxnSpPr>
              <p:spPr>
                <a:xfrm flipV="1">
                  <a:off x="1912266" y="3858693"/>
                  <a:ext cx="0" cy="11193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Gerade Verbindung 20"/>
                <p:cNvCxnSpPr/>
                <p:nvPr/>
              </p:nvCxnSpPr>
              <p:spPr>
                <a:xfrm flipV="1">
                  <a:off x="1907704" y="3861048"/>
                  <a:ext cx="387739" cy="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" name="Gerade Verbindung 21"/>
                <p:cNvCxnSpPr/>
                <p:nvPr/>
              </p:nvCxnSpPr>
              <p:spPr>
                <a:xfrm flipV="1">
                  <a:off x="2289505" y="3866181"/>
                  <a:ext cx="0" cy="1051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9" name="Textfeld 18"/>
              <p:cNvSpPr txBox="1"/>
              <p:nvPr/>
            </p:nvSpPr>
            <p:spPr>
              <a:xfrm>
                <a:off x="2108557" y="3683839"/>
                <a:ext cx="201798" cy="354418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23" name="Gruppieren 22"/>
            <p:cNvGrpSpPr/>
            <p:nvPr/>
          </p:nvGrpSpPr>
          <p:grpSpPr>
            <a:xfrm>
              <a:off x="2323543" y="6211276"/>
              <a:ext cx="405217" cy="354418"/>
              <a:chOff x="1885458" y="3683839"/>
              <a:chExt cx="648001" cy="354418"/>
            </a:xfrm>
          </p:grpSpPr>
          <p:grpSp>
            <p:nvGrpSpPr>
              <p:cNvPr id="24" name="Gruppieren 23"/>
              <p:cNvGrpSpPr/>
              <p:nvPr/>
            </p:nvGrpSpPr>
            <p:grpSpPr>
              <a:xfrm>
                <a:off x="1885458" y="3880098"/>
                <a:ext cx="648001" cy="61676"/>
                <a:chOff x="1907707" y="3858693"/>
                <a:chExt cx="387740" cy="112684"/>
              </a:xfrm>
            </p:grpSpPr>
            <p:cxnSp>
              <p:nvCxnSpPr>
                <p:cNvPr id="26" name="Gerade Verbindung 25"/>
                <p:cNvCxnSpPr/>
                <p:nvPr/>
              </p:nvCxnSpPr>
              <p:spPr>
                <a:xfrm flipV="1">
                  <a:off x="1912266" y="3858693"/>
                  <a:ext cx="0" cy="11193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" name="Gerade Verbindung 26"/>
                <p:cNvCxnSpPr/>
                <p:nvPr/>
              </p:nvCxnSpPr>
              <p:spPr>
                <a:xfrm flipV="1">
                  <a:off x="1907707" y="3861048"/>
                  <a:ext cx="387740" cy="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Gerade Verbindung 27"/>
                <p:cNvCxnSpPr/>
                <p:nvPr/>
              </p:nvCxnSpPr>
              <p:spPr>
                <a:xfrm flipV="1">
                  <a:off x="2289505" y="3866181"/>
                  <a:ext cx="0" cy="1051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5" name="Textfeld 24"/>
              <p:cNvSpPr txBox="1"/>
              <p:nvPr/>
            </p:nvSpPr>
            <p:spPr>
              <a:xfrm>
                <a:off x="2108557" y="3683839"/>
                <a:ext cx="201798" cy="354418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1" name="Gruppieren 30"/>
            <p:cNvGrpSpPr/>
            <p:nvPr/>
          </p:nvGrpSpPr>
          <p:grpSpPr>
            <a:xfrm>
              <a:off x="5020804" y="5863390"/>
              <a:ext cx="405217" cy="354418"/>
              <a:chOff x="1885458" y="3683839"/>
              <a:chExt cx="648001" cy="354418"/>
            </a:xfrm>
          </p:grpSpPr>
          <p:grpSp>
            <p:nvGrpSpPr>
              <p:cNvPr id="32" name="Gruppieren 31"/>
              <p:cNvGrpSpPr/>
              <p:nvPr/>
            </p:nvGrpSpPr>
            <p:grpSpPr>
              <a:xfrm>
                <a:off x="1885458" y="3880098"/>
                <a:ext cx="648001" cy="61676"/>
                <a:chOff x="1907707" y="3858693"/>
                <a:chExt cx="387740" cy="112684"/>
              </a:xfrm>
            </p:grpSpPr>
            <p:cxnSp>
              <p:nvCxnSpPr>
                <p:cNvPr id="34" name="Gerade Verbindung 33"/>
                <p:cNvCxnSpPr/>
                <p:nvPr/>
              </p:nvCxnSpPr>
              <p:spPr>
                <a:xfrm flipV="1">
                  <a:off x="1912266" y="3858693"/>
                  <a:ext cx="0" cy="11193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Gerade Verbindung 34"/>
                <p:cNvCxnSpPr/>
                <p:nvPr/>
              </p:nvCxnSpPr>
              <p:spPr>
                <a:xfrm flipV="1">
                  <a:off x="1907707" y="3861048"/>
                  <a:ext cx="387740" cy="2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Gerade Verbindung 35"/>
                <p:cNvCxnSpPr/>
                <p:nvPr/>
              </p:nvCxnSpPr>
              <p:spPr>
                <a:xfrm flipV="1">
                  <a:off x="2289505" y="3866181"/>
                  <a:ext cx="0" cy="1051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3" name="Textfeld 32"/>
              <p:cNvSpPr txBox="1"/>
              <p:nvPr/>
            </p:nvSpPr>
            <p:spPr>
              <a:xfrm>
                <a:off x="2108557" y="3683839"/>
                <a:ext cx="201798" cy="354418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0" name="Gruppieren 29"/>
            <p:cNvGrpSpPr/>
            <p:nvPr/>
          </p:nvGrpSpPr>
          <p:grpSpPr>
            <a:xfrm>
              <a:off x="4610576" y="5863390"/>
              <a:ext cx="395390" cy="354418"/>
              <a:chOff x="1885456" y="3683839"/>
              <a:chExt cx="648000" cy="354418"/>
            </a:xfrm>
          </p:grpSpPr>
          <p:grpSp>
            <p:nvGrpSpPr>
              <p:cNvPr id="37" name="Gruppieren 36"/>
              <p:cNvGrpSpPr/>
              <p:nvPr/>
            </p:nvGrpSpPr>
            <p:grpSpPr>
              <a:xfrm>
                <a:off x="1885456" y="3880098"/>
                <a:ext cx="648000" cy="61676"/>
                <a:chOff x="1907704" y="3858693"/>
                <a:chExt cx="387739" cy="112684"/>
              </a:xfrm>
            </p:grpSpPr>
            <p:cxnSp>
              <p:nvCxnSpPr>
                <p:cNvPr id="39" name="Gerade Verbindung 38"/>
                <p:cNvCxnSpPr/>
                <p:nvPr/>
              </p:nvCxnSpPr>
              <p:spPr>
                <a:xfrm flipV="1">
                  <a:off x="1912266" y="3858693"/>
                  <a:ext cx="0" cy="11193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0" name="Gerade Verbindung 39"/>
                <p:cNvCxnSpPr/>
                <p:nvPr/>
              </p:nvCxnSpPr>
              <p:spPr>
                <a:xfrm flipV="1">
                  <a:off x="1907704" y="3861048"/>
                  <a:ext cx="387739" cy="1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Gerade Verbindung 40"/>
                <p:cNvCxnSpPr/>
                <p:nvPr/>
              </p:nvCxnSpPr>
              <p:spPr>
                <a:xfrm flipV="1">
                  <a:off x="2289505" y="3866181"/>
                  <a:ext cx="0" cy="105196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8" name="Textfeld 37"/>
              <p:cNvSpPr txBox="1"/>
              <p:nvPr/>
            </p:nvSpPr>
            <p:spPr>
              <a:xfrm>
                <a:off x="2108557" y="3683839"/>
                <a:ext cx="201798" cy="354418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de-DE" sz="1400" dirty="0" smtClean="0">
                    <a:latin typeface="Arial" pitchFamily="34" charset="0"/>
                    <a:cs typeface="Arial" pitchFamily="34" charset="0"/>
                  </a:rPr>
                  <a:t>*</a:t>
                </a:r>
                <a:endParaRPr lang="de-DE" sz="14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44124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ildschirmpräsentation (4:3)</PresentationFormat>
  <Paragraphs>2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Uniklinik Frankfur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tin Large</dc:creator>
  <cp:lastModifiedBy>Prof. Dr. Franz Rödel</cp:lastModifiedBy>
  <cp:revision>109</cp:revision>
  <cp:lastPrinted>2014-03-04T12:13:54Z</cp:lastPrinted>
  <dcterms:created xsi:type="dcterms:W3CDTF">2013-12-13T10:42:43Z</dcterms:created>
  <dcterms:modified xsi:type="dcterms:W3CDTF">2014-03-09T13:48:45Z</dcterms:modified>
</cp:coreProperties>
</file>